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7" r:id="rId3"/>
    <p:sldId id="268" r:id="rId4"/>
    <p:sldId id="269" r:id="rId5"/>
    <p:sldId id="270" r:id="rId6"/>
    <p:sldId id="271" r:id="rId7"/>
    <p:sldId id="272" r:id="rId8"/>
    <p:sldId id="273" r:id="rId9"/>
    <p:sldId id="274" r:id="rId10"/>
    <p:sldId id="275" r:id="rId11"/>
    <p:sldId id="276" r:id="rId12"/>
    <p:sldId id="277" r:id="rId13"/>
    <p:sldId id="278" r:id="rId14"/>
    <p:sldId id="279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855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396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805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00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151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978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05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119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715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087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58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430B9-ED14-4E0B-A487-0DCCD4B6BB4C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988D9F-1855-4F0E-9779-D5C9CC5CA0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786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794957"/>
            <a:ext cx="9144000" cy="715005"/>
          </a:xfrm>
        </p:spPr>
        <p:txBody>
          <a:bodyPr>
            <a:normAutofit fontScale="90000"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4.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SEA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of 16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ranscription factors (TF) - coding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genes regulating expression of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77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LTR7- and LTR5_Hs-linked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enes. Related to Table 8.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2465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93620" y="910871"/>
            <a:ext cx="4510223" cy="512391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4098" name="Picture 2" descr="https://appyters.maayanlab.cloud/Enrichment_Analysis_Visualizer/3d16d2769a9ddfda36a01c79991eb0b80340b0fb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0690" y="2092568"/>
            <a:ext cx="6114964" cy="3886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6357839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62101" y="979354"/>
            <a:ext cx="4393726" cy="487915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5122" name="Picture 2" descr="https://appyters.maayanlab.cloud/Enrichment_Analysis_Visualizer/e54849b0bc449c5628b277c0b2035689ce9b6c4f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8543" y="2044460"/>
            <a:ext cx="6167887" cy="37352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33502336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28921" y="872052"/>
            <a:ext cx="4674125" cy="515842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2050" name="Picture 2" descr="https://appyters.maayanlab.cloud/Enrichment_Analysis_Visualizer/ae85d295523e5d0ef4b1a24999d9faaf943ce65c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1675" y="2074984"/>
            <a:ext cx="6087264" cy="39653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</p:spTree>
    <p:extLst>
      <p:ext uri="{BB962C8B-B14F-4D97-AF65-F5344CB8AC3E}">
        <p14:creationId xmlns:p14="http://schemas.microsoft.com/office/powerpoint/2010/main" val="78824552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69361" y="1052112"/>
            <a:ext cx="4406707" cy="489319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3074" name="Picture 2" descr="Enrichr_results_bar.png (1360×746)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9313" y="2234242"/>
            <a:ext cx="5701896" cy="37438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</p:spTree>
    <p:extLst>
      <p:ext uri="{BB962C8B-B14F-4D97-AF65-F5344CB8AC3E}">
        <p14:creationId xmlns:p14="http://schemas.microsoft.com/office/powerpoint/2010/main" val="20935706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32154" y="816491"/>
            <a:ext cx="4432585" cy="5079761"/>
          </a:xfrm>
          <a:prstGeom prst="rect">
            <a:avLst/>
          </a:prstGeom>
        </p:spPr>
      </p:pic>
      <p:pic>
        <p:nvPicPr>
          <p:cNvPr id="1026" name="Picture 2" descr="https://appyters.maayanlab.cloud/Enrichment_Analysis_Visualizer/a5304e8b5608e02c80d0b73f00c1be9cd882361a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8327" y="2044460"/>
            <a:ext cx="5926345" cy="3847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8511836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5118" y="1024947"/>
            <a:ext cx="5631003" cy="491865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114137" y="0"/>
            <a:ext cx="49774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i="0" u="none" strike="noStrike" dirty="0" smtClean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GSEA of 377 LTR7- and LTR5_Hs-linked  genes</a:t>
            </a:r>
          </a:p>
          <a:p>
            <a:pPr algn="ctr"/>
            <a:r>
              <a:rPr lang="en-US" b="1" dirty="0" smtClean="0">
                <a:solidFill>
                  <a:srgbClr val="000000"/>
                </a:solidFill>
                <a:latin typeface="Calibri" panose="020F0502020204030204" pitchFamily="34" charset="0"/>
              </a:rPr>
              <a:t>TF perturbations followed by expression database</a:t>
            </a:r>
            <a:endParaRPr lang="en-US" b="1" i="0" u="none" strike="noStrike" dirty="0" smtClean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7746521" y="1596597"/>
          <a:ext cx="2613804" cy="41833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13804"/>
              </a:tblGrid>
              <a:tr h="198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smtClean="0">
                          <a:effectLst/>
                        </a:rPr>
                        <a:t>16 TF-coding</a:t>
                      </a:r>
                      <a:r>
                        <a:rPr lang="en-US" sz="1400" b="1" u="none" strike="noStrike" baseline="0" dirty="0" smtClean="0">
                          <a:effectLst/>
                        </a:rPr>
                        <a:t> genes regulating expression LTR7- and LTR5_Hs-linked genes</a:t>
                      </a:r>
                      <a:endParaRPr lang="en-US" sz="1400" b="1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98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BACH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9812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BCL11B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DNMT1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EOM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HMGA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MYC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NKX25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RES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SATB1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SOX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SOX3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ET1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ET2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ET3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TWIST1</a:t>
                      </a:r>
                      <a:endParaRPr lang="en-US" sz="1400" b="1" i="0" u="none" strike="noStrike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VDR</a:t>
                      </a:r>
                      <a:endParaRPr lang="en-US" sz="1400" b="1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5423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11266" name="Picture 2" descr="https://appyters.maayanlab.cloud/Enrichment_Analysis_Visualizer/c255bd0d4224a71ad7b874fa667fb8a7a77108c3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15796" y="2156604"/>
            <a:ext cx="6142008" cy="38473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942143" y="1065799"/>
            <a:ext cx="4497245" cy="485006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8806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12290" name="Picture 2" descr="https://appyters.maayanlab.cloud/Enrichment_Analysis_Visualizer/83a9c8c20f7d95473e26e045a23ccc290f0582b6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95026" y="1731006"/>
            <a:ext cx="6137752" cy="37057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952553" y="678017"/>
            <a:ext cx="4357847" cy="472709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138971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834658" y="955428"/>
            <a:ext cx="4485736" cy="485225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10242" name="Picture 2" descr="https://appyters.maayanlab.cloud/Enrichment_Analysis_Visualizer/354122ad787a23e7e3f1d00fb8f7c7082ac81403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3653" y="2019826"/>
            <a:ext cx="6142007" cy="38633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993934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142690" y="978786"/>
            <a:ext cx="4139286" cy="494495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8194" name="Picture 2" descr="https://appyters.maayanlab.cloud/Enrichment_Analysis_Visualizer/23699521acf88c34e220688225def66c8ff06418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84811" y="2221913"/>
            <a:ext cx="6090246" cy="3523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6961584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98743" y="1093636"/>
            <a:ext cx="4225551" cy="497404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9218" name="Picture 2" descr="https://appyters.maayanlab.cloud/Enrichment_Analysis_Visualizer/61ebf48f8ead60e20fdd03882b009d32e74ba1af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98542" y="2304752"/>
            <a:ext cx="5874590" cy="36129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5214376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789977" y="952721"/>
            <a:ext cx="4566021" cy="494991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6146" name="Picture 2" descr="https://appyters.maayanlab.cloud/Enrichment_Analysis_Visualizer/b512b15f8f676f46d5ab83188a6f617be6f78eb0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7947" y="2035835"/>
            <a:ext cx="6296122" cy="39250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24935668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943751" y="1073149"/>
            <a:ext cx="4488617" cy="502799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091131" y="0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b="1" dirty="0"/>
              <a:t>GSEA of 16 TF coding genes </a:t>
            </a:r>
            <a:r>
              <a:rPr lang="en-US" b="1" dirty="0" smtClean="0"/>
              <a:t>regulating </a:t>
            </a:r>
            <a:r>
              <a:rPr lang="en-US" b="1" dirty="0"/>
              <a:t>expression of </a:t>
            </a:r>
            <a:endParaRPr lang="en-US" b="1" dirty="0" smtClean="0"/>
          </a:p>
          <a:p>
            <a:pPr algn="ctr"/>
            <a:r>
              <a:rPr lang="en-US" b="1" dirty="0" smtClean="0"/>
              <a:t>377 LTR7- and LTR5_Hs-linked genes</a:t>
            </a:r>
            <a:endParaRPr lang="en-US" b="1" dirty="0"/>
          </a:p>
        </p:txBody>
      </p:sp>
      <p:pic>
        <p:nvPicPr>
          <p:cNvPr id="7170" name="Picture 2" descr="https://appyters.maayanlab.cloud/Enrichment_Analysis_Visualizer/85cd54c080154683feb93ea06c1c84e4d3517a1a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2060" y="2270544"/>
            <a:ext cx="5995360" cy="37851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7586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248</Words>
  <Application>Microsoft Office PowerPoint</Application>
  <PresentationFormat>Widescreen</PresentationFormat>
  <Paragraphs>57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Supplemental Figure S4. GSEA of 16 transcription factors (TF) - coding genes regulating expression of 377 LTR7- and LTR5_Hs-linked genes. Related to Table 8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377 LTR7-linked  genes among 935 LTR5_Hs linked genes</dc:title>
  <dc:creator>Guennadi Glinskii</dc:creator>
  <cp:lastModifiedBy>Guennadi Glinskii</cp:lastModifiedBy>
  <cp:revision>20</cp:revision>
  <dcterms:created xsi:type="dcterms:W3CDTF">2022-03-05T10:12:02Z</dcterms:created>
  <dcterms:modified xsi:type="dcterms:W3CDTF">2022-04-21T05:39:56Z</dcterms:modified>
</cp:coreProperties>
</file>